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7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64" userDrawn="1">
          <p15:clr>
            <a:srgbClr val="A4A3A4"/>
          </p15:clr>
        </p15:guide>
        <p15:guide id="2" pos="4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600FF"/>
    <a:srgbClr val="A5FF6B"/>
    <a:srgbClr val="FF9231"/>
    <a:srgbClr val="EA003F"/>
    <a:srgbClr val="E13AFE"/>
    <a:srgbClr val="DB9700"/>
    <a:srgbClr val="00F2A1"/>
    <a:srgbClr val="00907C"/>
    <a:srgbClr val="4A4FC5"/>
    <a:srgbClr val="E9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5"/>
    <p:restoredTop sz="94694"/>
  </p:normalViewPr>
  <p:slideViewPr>
    <p:cSldViewPr snapToGrid="0" snapToObjects="1">
      <p:cViewPr varScale="1">
        <p:scale>
          <a:sx n="82" d="100"/>
          <a:sy n="82" d="100"/>
        </p:scale>
        <p:origin x="4080" y="192"/>
      </p:cViewPr>
      <p:guideLst>
        <p:guide orient="horz" pos="5064"/>
        <p:guide pos="4224"/>
      </p:guideLst>
    </p:cSldViewPr>
  </p:slideViewPr>
  <p:notesTextViewPr>
    <p:cViewPr>
      <p:scale>
        <a:sx n="85" d="100"/>
        <a:sy n="8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0D109F-9FEC-DA44-A69C-E029EAED4A05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61CA8D-B548-7247-B2E9-BB70CA9702F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3202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76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4313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355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9613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821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056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57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929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2369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9584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881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34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A543F86-4D6A-DF4C-BA0A-F840A66405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2164611"/>
              </p:ext>
            </p:extLst>
          </p:nvPr>
        </p:nvGraphicFramePr>
        <p:xfrm>
          <a:off x="131549" y="1424339"/>
          <a:ext cx="7013171" cy="26547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25941">
                  <a:extLst>
                    <a:ext uri="{9D8B030D-6E8A-4147-A177-3AD203B41FA5}">
                      <a16:colId xmlns:a16="http://schemas.microsoft.com/office/drawing/2014/main" val="556130888"/>
                    </a:ext>
                  </a:extLst>
                </a:gridCol>
                <a:gridCol w="1133659">
                  <a:extLst>
                    <a:ext uri="{9D8B030D-6E8A-4147-A177-3AD203B41FA5}">
                      <a16:colId xmlns:a16="http://schemas.microsoft.com/office/drawing/2014/main" val="947563387"/>
                    </a:ext>
                  </a:extLst>
                </a:gridCol>
                <a:gridCol w="2992990">
                  <a:extLst>
                    <a:ext uri="{9D8B030D-6E8A-4147-A177-3AD203B41FA5}">
                      <a16:colId xmlns:a16="http://schemas.microsoft.com/office/drawing/2014/main" val="349550496"/>
                    </a:ext>
                  </a:extLst>
                </a:gridCol>
                <a:gridCol w="786253">
                  <a:extLst>
                    <a:ext uri="{9D8B030D-6E8A-4147-A177-3AD203B41FA5}">
                      <a16:colId xmlns:a16="http://schemas.microsoft.com/office/drawing/2014/main" val="1694150760"/>
                    </a:ext>
                  </a:extLst>
                </a:gridCol>
                <a:gridCol w="1450129">
                  <a:extLst>
                    <a:ext uri="{9D8B030D-6E8A-4147-A177-3AD203B41FA5}">
                      <a16:colId xmlns:a16="http://schemas.microsoft.com/office/drawing/2014/main" val="1131379511"/>
                    </a:ext>
                  </a:extLst>
                </a:gridCol>
                <a:gridCol w="224199">
                  <a:extLst>
                    <a:ext uri="{9D8B030D-6E8A-4147-A177-3AD203B41FA5}">
                      <a16:colId xmlns:a16="http://schemas.microsoft.com/office/drawing/2014/main" val="2055564984"/>
                    </a:ext>
                  </a:extLst>
                </a:gridCol>
              </a:tblGrid>
              <a:tr h="142007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3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TAM-MSP primer and probe characteristics</a:t>
                      </a: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0005083"/>
                  </a:ext>
                </a:extLst>
              </a:tr>
              <a:tr h="33124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/Probe Na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 To 3' Sequenc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ray Target ID</a:t>
                      </a:r>
                      <a:endParaRPr lang="en-US" sz="800" dirty="0"/>
                    </a:p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Location (hg38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bp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517519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9941753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Ext_Tail_F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TGCCTGAGTATGAACGAAGAGATAGCGGCG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910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:61,200,782-61,200,86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2789355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Ext_Tail_R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GATGTCAGTTAGGACGACCGAACCGAACAACT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2688128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M_Prob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CCCCGAACTCTACG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4498112"/>
                  </a:ext>
                </a:extLst>
              </a:tr>
              <a:tr h="140991">
                <a:tc gridSpan="3"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9634098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Tail_F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TGCCTGAGTATGAATGTTGGAGTTATTGATGTTAT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190895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5:51,681,379-51,681,484</a:t>
                      </a:r>
                      <a:endParaRPr lang="en-US" sz="800" b="0" i="0" u="none" strike="noStrike" dirty="0">
                        <a:solidFill>
                          <a:srgbClr val="495057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0524063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Tail_R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GATGTCAGTTAGGACCAAAACATAACTTTACTCTCACT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2680397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M_Prob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GCATACTCCATACACG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8920806"/>
                  </a:ext>
                </a:extLst>
              </a:tr>
              <a:tr h="140991">
                <a:tc gridSpan="3"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3779065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Tail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TGCCTGAGTATGAAGTTTTTATTTATTTAGGAAGGAAG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7:5,528,269-5,528,34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9506819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Tail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GATGTCAGTTAGGACAAATCATCACCATTAACAATAAAC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5277908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Prob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ACCCTAAAACACTCTTCC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3611175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8918295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_Internal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TGCCTGAGTATGA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5366143"/>
                  </a:ext>
                </a:extLst>
              </a:tr>
              <a:tr h="1409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_Internal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GATGTCAGTTAGGA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79781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258275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77</TotalTime>
  <Words>126</Words>
  <Application>Microsoft Macintosh PowerPoint</Application>
  <PresentationFormat>Custom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dley Downs</dc:creator>
  <cp:lastModifiedBy>Bradley Downs</cp:lastModifiedBy>
  <cp:revision>449</cp:revision>
  <cp:lastPrinted>2021-03-15T15:34:39Z</cp:lastPrinted>
  <dcterms:created xsi:type="dcterms:W3CDTF">2019-09-14T17:51:09Z</dcterms:created>
  <dcterms:modified xsi:type="dcterms:W3CDTF">2021-04-29T16:21:37Z</dcterms:modified>
</cp:coreProperties>
</file>